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15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035D2DD-46ED-B8F9-E545-E30CDAB63A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706B6EC8-65DD-383F-58B7-AFA13D345BD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8445B1D-FF96-D24B-96D4-58CD215758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13486-76CC-4CA7-94DB-852C1DFC4C94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156B161-3E32-7BC5-DFE7-8086326BF7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E6D2D60-6A77-40A3-98D9-666EAE843A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A7F06-D2AE-4C6A-95EA-D4C3CB97F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7289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6ED2359-9328-1AF4-C15F-BBFF9C81AA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966143EA-7C1E-51B0-8FCF-2919DD8D52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4FB73848-1009-12F5-83BE-5CD4BE1B59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13486-76CC-4CA7-94DB-852C1DFC4C94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9A7AEC2-6276-FB9B-E9B3-984D807FB4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A308C54-B066-5FD1-9858-C985611584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A7F06-D2AE-4C6A-95EA-D4C3CB97F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955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5FEB101E-B28F-C59F-D485-EA295AC68EF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7B426DAF-29E2-A2A6-90B3-B1448EDC18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8DBCB60-074D-CB8D-019A-B89A769C79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13486-76CC-4CA7-94DB-852C1DFC4C94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8724099-DFB7-038B-4F48-CA9C5333F7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80E5CF2-AE95-E768-4C35-7FAB544058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A7F06-D2AE-4C6A-95EA-D4C3CB97F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05635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775D7E8-6AAE-A7C4-69D3-9BD8BBB15E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21CFF2BD-75B0-E69D-8DA6-0E5C1D2326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D3BFB45-62F3-DD7D-6ED9-65DEBA7477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13486-76CC-4CA7-94DB-852C1DFC4C94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FB5FE1D-0E04-85E1-CC7A-863D829662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D76827F-68CA-CEC1-EBB3-C436C724CA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A7F06-D2AE-4C6A-95EA-D4C3CB97F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53851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F52CAD5-4F7C-010A-B479-A5B6CD1F6F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6360FCE3-BB54-6905-EE2F-87D41F4CD4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837C656-366F-85FB-DD85-E0DE09B0C6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13486-76CC-4CA7-94DB-852C1DFC4C94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A757115-72F7-FFAC-1530-F725B8ADAF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3CC6AD2-98E3-547F-CDB8-DB8D9B4050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A7F06-D2AE-4C6A-95EA-D4C3CB97F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1490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4119002-CB11-F192-E739-BA354DDF0E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0F887CFF-CDE7-7864-6360-A0CD0D2516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478132D2-973B-848F-BD99-9C15914B30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19903CCB-5F60-8E7B-638D-5D55605B8E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13486-76CC-4CA7-94DB-852C1DFC4C94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3E390387-9590-476A-3DAA-EE5E14E030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68FE174B-8E3D-172B-D560-5AA4845CDB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A7F06-D2AE-4C6A-95EA-D4C3CB97F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693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AD49EE6-9EA8-E17A-8322-5041D9CBBB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F5C9340B-096A-8397-4830-BCD12F942C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D3E3286C-4CC8-1AA4-6A99-249603FBA1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82B6AD0A-FFA0-F041-D482-CA359CB6F3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BC77030D-670E-A67A-0AA6-C776D9C64B3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89234F28-E015-CADC-7EDA-D8DD3874E9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13486-76CC-4CA7-94DB-852C1DFC4C94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6BA5DFFE-0B61-A307-165D-D48DBD2B42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BE6DE969-9A5D-302B-23D9-6A7ADAD303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A7F06-D2AE-4C6A-95EA-D4C3CB97F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6868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4412C32-D02C-4CF3-4385-96CA143A62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99EB699E-0F9F-7C05-53D8-7AE725CD37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13486-76CC-4CA7-94DB-852C1DFC4C94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E92B214F-6315-E444-D5D2-99B4CD639D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B827621E-F8E9-5C69-EFD9-C660385934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A7F06-D2AE-4C6A-95EA-D4C3CB97F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60574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CEE142F5-A3DB-D80D-3BBE-FD9820AB3F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13486-76CC-4CA7-94DB-852C1DFC4C94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C7697DAC-B257-1C75-19A6-3A14967E7E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FCAE4AF1-74ED-5B55-334B-9193C792BF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A7F06-D2AE-4C6A-95EA-D4C3CB97F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3421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0C9B3D0-5246-BCE5-83DC-5DE8DAE710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6D68D773-BF3B-8BA0-BD70-254B21D1454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FB2C593D-01E5-A514-55DB-253C4D6663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E314E01F-3083-437B-AA2A-139DD5EF1B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13486-76CC-4CA7-94DB-852C1DFC4C94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DDC95B9-0D91-6633-EE24-2CC9AE60B2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E1BE0FC1-7498-D71A-3421-ABED4CD27D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A7F06-D2AE-4C6A-95EA-D4C3CB97F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229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68D66A8-5971-CCE9-E61A-3CAC87458F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769F5C29-FBDF-F446-75E9-4ECB638339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C79EE5D0-1FB5-6C02-0179-DE066AA15B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A43A24F7-EE4E-17C6-43BF-8C0CD53FA0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13486-76CC-4CA7-94DB-852C1DFC4C94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5D20140B-8657-7832-BFEE-6A6AD049C2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15AF6B53-450D-A258-9FC5-7A19001908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A7F06-D2AE-4C6A-95EA-D4C3CB97F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6049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62A82348-15C6-F989-430E-64E3112064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8B73FFD7-17A2-9035-BE4D-C642FCB4F7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3050C5B-9484-07C5-3C1B-AC4ED2817A2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513486-76CC-4CA7-94DB-852C1DFC4C94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31E0B96-7AC1-DC74-2285-D184E20646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51AC118-BFFB-9597-24CC-43774038CD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FA7F06-D2AE-4C6A-95EA-D4C3CB97F4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0080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microsoft.com/office/2007/relationships/hdphoto" Target="../media/hdphoto1.wdp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D489557C-2025-5BC0-D273-B9E65A3043A1}"/>
              </a:ext>
            </a:extLst>
          </p:cNvPr>
          <p:cNvSpPr txBox="1"/>
          <p:nvPr/>
        </p:nvSpPr>
        <p:spPr>
          <a:xfrm>
            <a:off x="2883877" y="102949"/>
            <a:ext cx="5083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igure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1: All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estern Blots Used for Analyses</a:t>
            </a:r>
          </a:p>
        </p:txBody>
      </p:sp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xmlns="" id="{BEF1A312-ABC6-7390-3FC6-D91830B12CC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429" y="804261"/>
            <a:ext cx="3317374" cy="2002439"/>
          </a:xfrm>
          <a:prstGeom prst="rect">
            <a:avLst/>
          </a:prstGeom>
        </p:spPr>
      </p:pic>
      <p:pic>
        <p:nvPicPr>
          <p:cNvPr id="4" name="Picture 3" descr="A picture containing text&#10;&#10;Description automatically generated">
            <a:extLst>
              <a:ext uri="{FF2B5EF4-FFF2-40B4-BE49-F238E27FC236}">
                <a16:creationId xmlns:a16="http://schemas.microsoft.com/office/drawing/2014/main" xmlns="" id="{802DE30C-C2B2-0965-8C46-3E9D1E455A6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108" y="3555524"/>
            <a:ext cx="3317374" cy="2002439"/>
          </a:xfrm>
          <a:prstGeom prst="rect">
            <a:avLst/>
          </a:prstGeom>
        </p:spPr>
      </p:pic>
      <p:pic>
        <p:nvPicPr>
          <p:cNvPr id="7" name="Picture 6" descr="A picture containing text&#10;&#10;Description automatically generated">
            <a:extLst>
              <a:ext uri="{FF2B5EF4-FFF2-40B4-BE49-F238E27FC236}">
                <a16:creationId xmlns:a16="http://schemas.microsoft.com/office/drawing/2014/main" xmlns="" id="{147F1FFB-5FCA-49A0-01C9-AECA5B89E05E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8803" y="726080"/>
            <a:ext cx="3319272" cy="1952513"/>
          </a:xfrm>
          <a:prstGeom prst="rect">
            <a:avLst/>
          </a:prstGeom>
        </p:spPr>
      </p:pic>
      <p:pic>
        <p:nvPicPr>
          <p:cNvPr id="9" name="Picture 8" descr="A picture containing text&#10;&#10;Description automatically generated">
            <a:extLst>
              <a:ext uri="{FF2B5EF4-FFF2-40B4-BE49-F238E27FC236}">
                <a16:creationId xmlns:a16="http://schemas.microsoft.com/office/drawing/2014/main" xmlns="" id="{EEDA59AF-2FEC-EBE3-6005-388A7938CB73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43431" y="829223"/>
            <a:ext cx="3319272" cy="1952513"/>
          </a:xfrm>
          <a:prstGeom prst="rect">
            <a:avLst/>
          </a:prstGeom>
        </p:spPr>
      </p:pic>
      <p:pic>
        <p:nvPicPr>
          <p:cNvPr id="11" name="Picture 10" descr="Text&#10;&#10;Description automatically generated with medium confidence">
            <a:extLst>
              <a:ext uri="{FF2B5EF4-FFF2-40B4-BE49-F238E27FC236}">
                <a16:creationId xmlns:a16="http://schemas.microsoft.com/office/drawing/2014/main" xmlns="" id="{C2BC988E-B5DD-E31B-2BF6-D3E18AF0A88E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11205" y="3426284"/>
            <a:ext cx="3319272" cy="2125289"/>
          </a:xfrm>
          <a:prstGeom prst="rect">
            <a:avLst/>
          </a:prstGeom>
        </p:spPr>
      </p:pic>
      <p:pic>
        <p:nvPicPr>
          <p:cNvPr id="13" name="Picture 12" descr="Table&#10;&#10;Description automatically generated with low confidence">
            <a:extLst>
              <a:ext uri="{FF2B5EF4-FFF2-40B4-BE49-F238E27FC236}">
                <a16:creationId xmlns:a16="http://schemas.microsoft.com/office/drawing/2014/main" xmlns="" id="{8DF71700-32FD-5F47-1DAF-CA68F8D5D4A2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43632" y="3555524"/>
            <a:ext cx="3319272" cy="199604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40E91A1B-2C7A-66FC-3EAE-A56D763654F4}"/>
              </a:ext>
            </a:extLst>
          </p:cNvPr>
          <p:cNvSpPr txBox="1"/>
          <p:nvPr/>
        </p:nvSpPr>
        <p:spPr>
          <a:xfrm>
            <a:off x="2585503" y="5919122"/>
            <a:ext cx="552587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28600" indent="-228600">
              <a:buAutoNum type="alphaLcParenR"/>
            </a:pPr>
            <a:r>
              <a:rPr lang="en-US" sz="1000" dirty="0">
                <a:latin typeface="Palatino Linotype" panose="02040502050505030304" pitchFamily="18" charset="0"/>
              </a:rPr>
              <a:t>Blot replicate 1 for VE-CAD quantification.  b) Blot Replicate 2 for VE-CAD quantification</a:t>
            </a:r>
          </a:p>
          <a:p>
            <a:pPr marL="228600" indent="-228600">
              <a:buAutoNum type="alphaLcParenR" startAt="3"/>
            </a:pPr>
            <a:r>
              <a:rPr lang="en-US" sz="1000" dirty="0">
                <a:latin typeface="Palatino Linotype" panose="02040502050505030304" pitchFamily="18" charset="0"/>
              </a:rPr>
              <a:t>Blot replicate 3 for VE-CAD quantification.  d) Blot replicate 1 for CL-5 quantification.  </a:t>
            </a:r>
          </a:p>
          <a:p>
            <a:r>
              <a:rPr lang="en-US" sz="1000" dirty="0">
                <a:latin typeface="Palatino Linotype" panose="02040502050505030304" pitchFamily="18" charset="0"/>
              </a:rPr>
              <a:t>e)    Blot replicate 2 for CL-5 quantification.  f) Blot replicate 3 for CL-5 quantification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680308" y="2946400"/>
            <a:ext cx="10472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a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5158154" y="2806700"/>
            <a:ext cx="6721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9042400" y="2769346"/>
            <a:ext cx="930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1617785" y="5689600"/>
            <a:ext cx="7971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5348439" y="5549790"/>
            <a:ext cx="812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e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8999415" y="5571557"/>
            <a:ext cx="101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995307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63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harmaceutics-1697095</dc:title>
  <dc:creator>Erika Liktor</dc:creator>
  <cp:lastModifiedBy>MDPI</cp:lastModifiedBy>
  <cp:revision>4</cp:revision>
  <dcterms:created xsi:type="dcterms:W3CDTF">2022-05-31T14:59:21Z</dcterms:created>
  <dcterms:modified xsi:type="dcterms:W3CDTF">2022-07-07T03:52:51Z</dcterms:modified>
</cp:coreProperties>
</file>